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media/image1.pct" ContentType="image/x-pict"/>
  <Override PartName="/ppt/media/image4.png" ContentType="image/png"/>
  <Override PartName="/ppt/media/image2.pct" ContentType="image/x-pict"/>
  <Override PartName="/ppt/media/image3.png" ContentType="image/png"/>
  <Override PartName="/ppt/media/image5.pct" ContentType="image/x-pict"/>
  <Override PartName="/ppt/media/image8.png" ContentType="image/png"/>
  <Override PartName="/ppt/media/image6.pct" ContentType="image/x-pict"/>
  <Override PartName="/ppt/media/image9.png" ContentType="image/png"/>
  <Override PartName="/ppt/media/image7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C17757-04FE-4F9A-BF4E-8DA89E2B937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4016D1-62AD-4481-8CBF-96D3C54C936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956543-7BC3-4CFD-AE49-2258C2D76B9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5B8447-CFB5-477C-A26B-50D1B90EFD0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C7775C-A27C-4564-87CF-3E6D9F3D5E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E962D1-9FFF-408F-8F43-7A7B9F332B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075BCF-25C1-4C9F-B0AC-149C1F2BD88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68BF4A-B7CA-4B32-ADA8-6A0E972A64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527040"/>
            <a:ext cx="5914800" cy="8875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D789CB-792D-43BE-B495-08A2D3B44D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BD26D9-9777-4BB7-BDFC-D023F1A19A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48B093-AFC0-4808-9EA5-D3AAB4DD67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B682AC-9CC6-436C-A144-F8D8D769C7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9182160"/>
            <a:ext cx="23148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4A09D96-AC21-4C7D-8513-CD50814113E7}" type="slidenum">
              <a:rPr b="0" lang="en-GB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ct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ct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oleObject" Target="../embeddings/oleObject3.bin"/><Relationship Id="rId8" Type="http://schemas.openxmlformats.org/officeDocument/2006/relationships/image" Target="../media/image5.pct"/><Relationship Id="rId9" Type="http://schemas.openxmlformats.org/officeDocument/2006/relationships/oleObject" Target="../embeddings/oleObject4.bin"/><Relationship Id="rId10" Type="http://schemas.openxmlformats.org/officeDocument/2006/relationships/image" Target="../media/image6.pct"/><Relationship Id="rId1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image" Target="../media/image9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53"/>
          <p:cNvSpPr/>
          <p:nvPr/>
        </p:nvSpPr>
        <p:spPr>
          <a:xfrm>
            <a:off x="3824280" y="4930920"/>
            <a:ext cx="2768760" cy="290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(nM)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0                0.1                   0.2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 Box 53"/>
          <p:cNvSpPr/>
          <p:nvPr/>
        </p:nvSpPr>
        <p:spPr>
          <a:xfrm>
            <a:off x="3841920" y="2424240"/>
            <a:ext cx="2766960" cy="290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(nM)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0                 0.1                   0.2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 Box 53"/>
          <p:cNvSpPr/>
          <p:nvPr/>
        </p:nvSpPr>
        <p:spPr>
          <a:xfrm>
            <a:off x="270000" y="4924440"/>
            <a:ext cx="2658960" cy="239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6000"/>
              </a:lnSpc>
              <a:spcAft>
                <a:spcPts val="763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 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(nM)       0                100                 200    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6000"/>
              </a:lnSpc>
              <a:spcAft>
                <a:spcPts val="763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 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 Box 53"/>
          <p:cNvSpPr/>
          <p:nvPr/>
        </p:nvSpPr>
        <p:spPr>
          <a:xfrm>
            <a:off x="287280" y="2424240"/>
            <a:ext cx="2657520" cy="241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6000"/>
              </a:lnSpc>
              <a:spcAft>
                <a:spcPts val="763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 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(nM)       0                100                 200    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6000"/>
              </a:lnSpc>
              <a:spcAft>
                <a:spcPts val="763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 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5" name=""/>
          <p:cNvGraphicFramePr/>
          <p:nvPr/>
        </p:nvGraphicFramePr>
        <p:xfrm>
          <a:off x="336600" y="569880"/>
          <a:ext cx="2865240" cy="21319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6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36600" y="569880"/>
                    <a:ext cx="2865240" cy="2131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7" name=""/>
          <p:cNvGraphicFramePr/>
          <p:nvPr/>
        </p:nvGraphicFramePr>
        <p:xfrm>
          <a:off x="3803760" y="3097080"/>
          <a:ext cx="2863800" cy="194148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8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803760" y="3097080"/>
                    <a:ext cx="2863800" cy="1941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9" name="TextBox 8"/>
          <p:cNvSpPr/>
          <p:nvPr/>
        </p:nvSpPr>
        <p:spPr>
          <a:xfrm rot="16200000">
            <a:off x="-769320" y="1420560"/>
            <a:ext cx="1898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% 4MU (pM) / Protein (µg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 Box 69"/>
          <p:cNvSpPr/>
          <p:nvPr/>
        </p:nvSpPr>
        <p:spPr>
          <a:xfrm>
            <a:off x="1454040" y="663480"/>
            <a:ext cx="825480" cy="28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7000"/>
              </a:lnSpc>
              <a:spcAft>
                <a:spcPts val="799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MG-6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7000"/>
              </a:lnSpc>
              <a:spcAft>
                <a:spcPts val="799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59"/>
          <p:cNvSpPr/>
          <p:nvPr/>
        </p:nvSpPr>
        <p:spPr>
          <a:xfrm>
            <a:off x="55440" y="436680"/>
            <a:ext cx="241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59"/>
          <p:cNvSpPr/>
          <p:nvPr/>
        </p:nvSpPr>
        <p:spPr>
          <a:xfrm>
            <a:off x="3533760" y="441360"/>
            <a:ext cx="241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3" name="Group 16"/>
          <p:cNvGrpSpPr/>
          <p:nvPr/>
        </p:nvGrpSpPr>
        <p:grpSpPr>
          <a:xfrm>
            <a:off x="568440" y="174600"/>
            <a:ext cx="5605200" cy="306000"/>
            <a:chOff x="568440" y="174600"/>
            <a:chExt cx="5605200" cy="306000"/>
          </a:xfrm>
        </p:grpSpPr>
        <p:sp>
          <p:nvSpPr>
            <p:cNvPr id="54" name="TextBox 58"/>
            <p:cNvSpPr/>
            <p:nvPr/>
          </p:nvSpPr>
          <p:spPr>
            <a:xfrm>
              <a:off x="3835440" y="179280"/>
              <a:ext cx="1123920" cy="30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1,25(OH)</a:t>
              </a:r>
              <a:r>
                <a:rPr b="1" lang="en-GB" sz="1200" spc="-1" strike="noStrike" baseline="-25000">
                  <a:solidFill>
                    <a:srgbClr val="000000"/>
                  </a:solidFill>
                  <a:latin typeface="Times New Roman"/>
                  <a:ea typeface="Calibri"/>
                </a:rPr>
                <a:t>2</a:t>
              </a: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D</a:t>
              </a:r>
              <a:r>
                <a:rPr b="1" lang="en-GB" sz="1200" spc="-1" strike="noStrike" baseline="-25000">
                  <a:solidFill>
                    <a:srgbClr val="000000"/>
                  </a:solidFill>
                  <a:latin typeface="Times New Roman"/>
                  <a:ea typeface="Calibri"/>
                </a:rPr>
                <a:t>2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Rectangle 18"/>
            <p:cNvSpPr/>
            <p:nvPr/>
          </p:nvSpPr>
          <p:spPr>
            <a:xfrm flipV="1">
              <a:off x="4896360" y="237600"/>
              <a:ext cx="160200" cy="160200"/>
            </a:xfrm>
            <a:prstGeom prst="rect">
              <a:avLst/>
            </a:prstGeom>
            <a:blipFill rotWithShape="0">
              <a:blip r:embed="rId5"/>
              <a:srcRect/>
              <a:tile tx="0" ty="0" sx="100000" sy="100000" algn="ctr"/>
            </a:blip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ffffff"/>
                  </a:solidFill>
                  <a:latin typeface="Times New Roman"/>
                  <a:ea typeface="Times New Roman"/>
                </a:rPr>
                <a:t> 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Rectangle 19"/>
            <p:cNvSpPr/>
            <p:nvPr/>
          </p:nvSpPr>
          <p:spPr>
            <a:xfrm flipV="1">
              <a:off x="3705480" y="237600"/>
              <a:ext cx="160200" cy="160200"/>
            </a:xfrm>
            <a:prstGeom prst="rect">
              <a:avLst/>
            </a:prstGeom>
            <a:blipFill rotWithShape="0">
              <a:blip r:embed="rId6"/>
              <a:srcRect/>
              <a:tile tx="0" ty="0" sx="100000" sy="100000" algn="ctr"/>
            </a:blip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ffffff"/>
                  </a:solidFill>
                  <a:latin typeface="Times New Roman"/>
                  <a:ea typeface="Times New Roman"/>
                </a:rPr>
                <a:t> 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Box 66"/>
            <p:cNvSpPr/>
            <p:nvPr/>
          </p:nvSpPr>
          <p:spPr>
            <a:xfrm>
              <a:off x="5049720" y="174600"/>
              <a:ext cx="1123920" cy="30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1,25(OH)</a:t>
              </a:r>
              <a:r>
                <a:rPr b="1" lang="en-GB" sz="1200" spc="-1" strike="noStrike" baseline="-25000">
                  <a:solidFill>
                    <a:srgbClr val="000000"/>
                  </a:solidFill>
                  <a:latin typeface="Times New Roman"/>
                  <a:ea typeface="Calibri"/>
                </a:rPr>
                <a:t>2</a:t>
              </a: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D</a:t>
              </a:r>
              <a:r>
                <a:rPr b="1" lang="en-GB" sz="1200" spc="-1" strike="noStrike" baseline="-25000">
                  <a:solidFill>
                    <a:srgbClr val="000000"/>
                  </a:solidFill>
                  <a:latin typeface="Times New Roman"/>
                  <a:ea typeface="Calibri"/>
                </a:rPr>
                <a:t>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Rectangle 21"/>
            <p:cNvSpPr/>
            <p:nvPr/>
          </p:nvSpPr>
          <p:spPr>
            <a:xfrm flipV="1">
              <a:off x="1530000" y="238320"/>
              <a:ext cx="160560" cy="16056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ffffff"/>
                  </a:solidFill>
                  <a:latin typeface="Times New Roman"/>
                  <a:ea typeface="Times New Roman"/>
                </a:rPr>
                <a:t> 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Rectangle 22"/>
            <p:cNvSpPr/>
            <p:nvPr/>
          </p:nvSpPr>
          <p:spPr>
            <a:xfrm flipV="1">
              <a:off x="2622960" y="238680"/>
              <a:ext cx="159840" cy="15984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ffffff"/>
                  </a:solidFill>
                  <a:latin typeface="Times New Roman"/>
                  <a:ea typeface="Times New Roman"/>
                </a:rPr>
                <a:t> 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Rectangle 23"/>
            <p:cNvSpPr/>
            <p:nvPr/>
          </p:nvSpPr>
          <p:spPr>
            <a:xfrm flipV="1">
              <a:off x="568440" y="238680"/>
              <a:ext cx="159840" cy="159840"/>
            </a:xfrm>
            <a:prstGeom prst="rect">
              <a:avLst/>
            </a:prstGeom>
            <a:solidFill>
              <a:srgbClr val="d9d9d9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ffffff"/>
                  </a:solidFill>
                  <a:latin typeface="Times New Roman"/>
                  <a:ea typeface="Times New Roman"/>
                </a:rPr>
                <a:t> 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TextBox 66"/>
            <p:cNvSpPr/>
            <p:nvPr/>
          </p:nvSpPr>
          <p:spPr>
            <a:xfrm>
              <a:off x="2743200" y="179280"/>
              <a:ext cx="950760" cy="30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25(OH)D</a:t>
              </a:r>
              <a:r>
                <a:rPr b="1" lang="en-GB" sz="1200" spc="-1" strike="noStrike" baseline="-25000">
                  <a:solidFill>
                    <a:srgbClr val="000000"/>
                  </a:solidFill>
                  <a:latin typeface="Times New Roman"/>
                  <a:ea typeface="Calibri"/>
                </a:rPr>
                <a:t>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TextBox 66"/>
            <p:cNvSpPr/>
            <p:nvPr/>
          </p:nvSpPr>
          <p:spPr>
            <a:xfrm>
              <a:off x="1646280" y="179280"/>
              <a:ext cx="954000" cy="30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25(OH)D</a:t>
              </a:r>
              <a:r>
                <a:rPr b="1" lang="en-GB" sz="1200" spc="-1" strike="noStrike" baseline="-25000">
                  <a:solidFill>
                    <a:srgbClr val="000000"/>
                  </a:solidFill>
                  <a:latin typeface="Times New Roman"/>
                  <a:ea typeface="Calibri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TextBox 66"/>
            <p:cNvSpPr/>
            <p:nvPr/>
          </p:nvSpPr>
          <p:spPr>
            <a:xfrm>
              <a:off x="676080" y="179280"/>
              <a:ext cx="871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Vehicl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aphicFrame>
        <p:nvGraphicFramePr>
          <p:cNvPr id="64" name=""/>
          <p:cNvGraphicFramePr/>
          <p:nvPr/>
        </p:nvGraphicFramePr>
        <p:xfrm>
          <a:off x="3727440" y="542880"/>
          <a:ext cx="2876400" cy="215424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65" name="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3727440" y="542880"/>
                    <a:ext cx="2876400" cy="2154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6" name=""/>
          <p:cNvGraphicFramePr/>
          <p:nvPr/>
        </p:nvGraphicFramePr>
        <p:xfrm>
          <a:off x="322200" y="3094200"/>
          <a:ext cx="2863800" cy="213192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67" name="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322200" y="3094200"/>
                    <a:ext cx="2863800" cy="2131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8" name="TextBox 32"/>
          <p:cNvSpPr/>
          <p:nvPr/>
        </p:nvSpPr>
        <p:spPr>
          <a:xfrm rot="16200000">
            <a:off x="2724120" y="1419120"/>
            <a:ext cx="1898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% 4MU (pM) / Protein (µg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33"/>
          <p:cNvSpPr/>
          <p:nvPr/>
        </p:nvSpPr>
        <p:spPr>
          <a:xfrm rot="16200000">
            <a:off x="2752920" y="3981240"/>
            <a:ext cx="1898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% 4MU (pM) / Protein (µg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34"/>
          <p:cNvSpPr/>
          <p:nvPr/>
        </p:nvSpPr>
        <p:spPr>
          <a:xfrm rot="16200000">
            <a:off x="-772560" y="3989160"/>
            <a:ext cx="1898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% 4MU (pM) / Protein (µg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 Box 69"/>
          <p:cNvSpPr/>
          <p:nvPr/>
        </p:nvSpPr>
        <p:spPr>
          <a:xfrm>
            <a:off x="4944960" y="663480"/>
            <a:ext cx="825480" cy="28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7000"/>
              </a:lnSpc>
              <a:spcAft>
                <a:spcPts val="799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MG-6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7000"/>
              </a:lnSpc>
              <a:spcAft>
                <a:spcPts val="799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 Box 69"/>
          <p:cNvSpPr/>
          <p:nvPr/>
        </p:nvSpPr>
        <p:spPr>
          <a:xfrm>
            <a:off x="4941720" y="3168720"/>
            <a:ext cx="825840" cy="28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7000"/>
              </a:lnSpc>
              <a:spcAft>
                <a:spcPts val="799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SaOS-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7000"/>
              </a:lnSpc>
              <a:spcAft>
                <a:spcPts val="799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 Box 69"/>
          <p:cNvSpPr/>
          <p:nvPr/>
        </p:nvSpPr>
        <p:spPr>
          <a:xfrm>
            <a:off x="1398600" y="3168720"/>
            <a:ext cx="826920" cy="28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7000"/>
              </a:lnSpc>
              <a:spcAft>
                <a:spcPts val="799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SaOS-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7000"/>
              </a:lnSpc>
              <a:spcAft>
                <a:spcPts val="799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59"/>
          <p:cNvSpPr/>
          <p:nvPr/>
        </p:nvSpPr>
        <p:spPr>
          <a:xfrm>
            <a:off x="93600" y="2932200"/>
            <a:ext cx="241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59"/>
          <p:cNvSpPr/>
          <p:nvPr/>
        </p:nvSpPr>
        <p:spPr>
          <a:xfrm>
            <a:off x="3571920" y="2936880"/>
            <a:ext cx="241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Rectangle 40"/>
          <p:cNvSpPr/>
          <p:nvPr/>
        </p:nvSpPr>
        <p:spPr>
          <a:xfrm>
            <a:off x="230040" y="5446800"/>
            <a:ext cx="6386760" cy="208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mparative effects of 25(OH)D</a:t>
            </a:r>
            <a:r>
              <a:rPr b="1" lang="en-GB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25(OH)D</a:t>
            </a:r>
            <a:r>
              <a:rPr b="1" lang="en-GB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3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1,25(OH)</a:t>
            </a:r>
            <a:r>
              <a:rPr b="1" lang="en-GB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r>
              <a:rPr b="1" lang="en-GB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1,25(OH)</a:t>
            </a:r>
            <a:r>
              <a:rPr b="1" lang="en-GB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r>
              <a:rPr b="1" lang="en-GB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3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on ALP enzyme activity.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MG-63 and SaOS-2 cells (1x10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Calibri"/>
              </a:rPr>
              <a:t>4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) were grown in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Lucida Sans Unicode"/>
              </a:rPr>
              <a:t>DMEM-10% FBS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 culture medium untill confluency (48hr), then introduced to osteogenic differentiation medium and treated every other day with either (A&amp;B) 100-200nM 25(OH)D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Times New Roman"/>
                <a:ea typeface="Calibri"/>
              </a:rPr>
              <a:t>2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/D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Times New Roman"/>
                <a:ea typeface="Calibri"/>
              </a:rPr>
              <a:t>3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 or (B&amp;C) 0.1-0.2nM of 1,25(OH)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Times New Roman"/>
                <a:ea typeface="Calibri"/>
              </a:rPr>
              <a:t>2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D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Times New Roman"/>
                <a:ea typeface="Calibri"/>
              </a:rPr>
              <a:t>2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 and D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Times New Roman"/>
                <a:ea typeface="Calibri"/>
              </a:rPr>
              <a:t>3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. 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Lucida Sans Unicode"/>
              </a:rPr>
              <a:t>Cultures were stopped on day 6 and ALP activity was measured.  ALP activities were normalised to total protein content.  Mean ± SEM enzymatic activity values from triplicate experiments have been presented as the amount of 4-methylumbelliferone (%4MU) generated after 45 min at 37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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Lucida Sans Unicode"/>
              </a:rPr>
              <a:t>C.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TextBox 4"/>
          <p:cNvSpPr/>
          <p:nvPr/>
        </p:nvSpPr>
        <p:spPr>
          <a:xfrm>
            <a:off x="806400" y="1281240"/>
            <a:ext cx="64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OS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5"/>
          <p:cNvSpPr/>
          <p:nvPr/>
        </p:nvSpPr>
        <p:spPr>
          <a:xfrm>
            <a:off x="806400" y="3033720"/>
            <a:ext cx="64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B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8"/>
          <p:cNvSpPr/>
          <p:nvPr/>
        </p:nvSpPr>
        <p:spPr>
          <a:xfrm>
            <a:off x="3848040" y="250920"/>
            <a:ext cx="107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SaOS-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10"/>
          <p:cNvSpPr/>
          <p:nvPr/>
        </p:nvSpPr>
        <p:spPr>
          <a:xfrm>
            <a:off x="1989000" y="250920"/>
            <a:ext cx="962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MG-6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1" name="Group 11"/>
          <p:cNvGrpSpPr/>
          <p:nvPr/>
        </p:nvGrpSpPr>
        <p:grpSpPr>
          <a:xfrm>
            <a:off x="1501920" y="558720"/>
            <a:ext cx="3749400" cy="3540240"/>
            <a:chOff x="1501920" y="558720"/>
            <a:chExt cx="3749400" cy="3540240"/>
          </a:xfrm>
        </p:grpSpPr>
        <p:pic>
          <p:nvPicPr>
            <p:cNvPr id="82" name="Picture 1" descr=""/>
            <p:cNvPicPr/>
            <p:nvPr/>
          </p:nvPicPr>
          <p:blipFill>
            <a:blip r:embed="rId1"/>
            <a:stretch/>
          </p:blipFill>
          <p:spPr>
            <a:xfrm>
              <a:off x="3518640" y="2390040"/>
              <a:ext cx="1732680" cy="170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3" name="Picture 2" descr=""/>
            <p:cNvPicPr/>
            <p:nvPr/>
          </p:nvPicPr>
          <p:blipFill>
            <a:blip r:embed="rId2"/>
            <a:stretch/>
          </p:blipFill>
          <p:spPr>
            <a:xfrm>
              <a:off x="3432600" y="558720"/>
              <a:ext cx="1818720" cy="1722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4" name="Picture 6" descr=""/>
            <p:cNvPicPr/>
            <p:nvPr/>
          </p:nvPicPr>
          <p:blipFill>
            <a:blip r:embed="rId3"/>
            <a:stretch/>
          </p:blipFill>
          <p:spPr>
            <a:xfrm>
              <a:off x="1501920" y="558720"/>
              <a:ext cx="1733760" cy="35290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85" name="Rectangle 3"/>
          <p:cNvSpPr/>
          <p:nvPr/>
        </p:nvSpPr>
        <p:spPr>
          <a:xfrm>
            <a:off x="409680" y="4341960"/>
            <a:ext cx="6200640" cy="2009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Representative images of MG-63 and SaOS-2 osteoblast – like cells in the presence (top row; OSM) or absence (bottom row; FBS) of osteogenic medium (OSM) containing 10mM β-glycerophosphate, and 50 µg/ml L-ascorbic acid over 28 days. Osteoblast-like cells (1x10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Calibri"/>
              </a:rPr>
              <a:t>4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) were grown to full confluency (48 hr) in DMEM-10%FBS, when media were replaced with OSM. Cultures were stopped on day 28, fixed in 70% ethanol, washed with deionised water and stained with Alizarin red staining solution. Plates were washed with deionised water and scanned with an Epson AX10 scanner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8-19T11:52:44Z</dcterms:created>
  <dc:creator>Ali Zarei</dc:creator>
  <dc:description/>
  <dc:language>en-US</dc:language>
  <cp:lastModifiedBy>Office 2004 Test Drive User</cp:lastModifiedBy>
  <dcterms:modified xsi:type="dcterms:W3CDTF">2016-09-22T16:02:58Z</dcterms:modified>
  <cp:revision>11</cp:revision>
  <dc:subject/>
  <dc:title>PowerPoint Presentation</dc:title>
</cp:coreProperties>
</file>